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52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BCE0E-913C-48D4-8A87-769967F58990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9248F-38F7-4203-A059-A21B57D3EC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BCE0E-913C-48D4-8A87-769967F58990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9248F-38F7-4203-A059-A21B57D3EC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BCE0E-913C-48D4-8A87-769967F58990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9248F-38F7-4203-A059-A21B57D3EC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BCE0E-913C-48D4-8A87-769967F58990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9248F-38F7-4203-A059-A21B57D3EC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BCE0E-913C-48D4-8A87-769967F58990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9248F-38F7-4203-A059-A21B57D3EC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BCE0E-913C-48D4-8A87-769967F58990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9248F-38F7-4203-A059-A21B57D3EC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BCE0E-913C-48D4-8A87-769967F58990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9248F-38F7-4203-A059-A21B57D3EC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BCE0E-913C-48D4-8A87-769967F58990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9248F-38F7-4203-A059-A21B57D3EC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BCE0E-913C-48D4-8A87-769967F58990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9248F-38F7-4203-A059-A21B57D3EC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BCE0E-913C-48D4-8A87-769967F58990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9248F-38F7-4203-A059-A21B57D3EC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BCE0E-913C-48D4-8A87-769967F58990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9248F-38F7-4203-A059-A21B57D3EC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9BCE0E-913C-48D4-8A87-769967F58990}" type="datetimeFigureOut">
              <a:rPr lang="en-US" smtClean="0"/>
              <a:t>1/3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9248F-38F7-4203-A059-A21B57D3EC10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3" descr="C:\Users\William Coley\Desktop\InvertZbtb32.png"/>
          <p:cNvPicPr>
            <a:picLocks noChangeAspect="1" noChangeArrowheads="1"/>
          </p:cNvPicPr>
          <p:nvPr/>
        </p:nvPicPr>
        <p:blipFill>
          <a:blip r:embed="rId2" cstate="print"/>
          <a:stretch>
            <a:fillRect/>
          </a:stretch>
        </p:blipFill>
        <p:spPr bwMode="auto">
          <a:xfrm>
            <a:off x="228600" y="2133600"/>
            <a:ext cx="8147419" cy="2438400"/>
          </a:xfrm>
          <a:prstGeom prst="rect">
            <a:avLst/>
          </a:prstGeom>
          <a:noFill/>
          <a:ln>
            <a:noFill/>
          </a:ln>
        </p:spPr>
      </p:pic>
      <p:sp>
        <p:nvSpPr>
          <p:cNvPr id="24" name="TextBox 23"/>
          <p:cNvSpPr txBox="1"/>
          <p:nvPr/>
        </p:nvSpPr>
        <p:spPr>
          <a:xfrm>
            <a:off x="152400" y="6324600"/>
            <a:ext cx="17234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aw data Fig. 1C</a:t>
            </a:r>
            <a:endParaRPr lang="en-US" dirty="0"/>
          </a:p>
        </p:txBody>
      </p:sp>
      <p:cxnSp>
        <p:nvCxnSpPr>
          <p:cNvPr id="28" name="Straight Arrow Connector 27"/>
          <p:cNvCxnSpPr/>
          <p:nvPr/>
        </p:nvCxnSpPr>
        <p:spPr>
          <a:xfrm flipV="1">
            <a:off x="1371600" y="4648200"/>
            <a:ext cx="0" cy="60960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flipV="1">
            <a:off x="2209800" y="4648200"/>
            <a:ext cx="0" cy="60960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 flipV="1">
            <a:off x="3048000" y="4648200"/>
            <a:ext cx="0" cy="60960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 flipV="1">
            <a:off x="3886200" y="4648200"/>
            <a:ext cx="0" cy="60960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 descr="Z:\TarbellGroup\GroupMembers\Will\Zbtb32 Projects\GenotypingExample.tif"/>
          <p:cNvPicPr>
            <a:picLocks noChangeAspect="1" noChangeArrowheads="1"/>
          </p:cNvPicPr>
          <p:nvPr/>
        </p:nvPicPr>
        <p:blipFill>
          <a:blip r:embed="rId2" cstate="print"/>
          <a:stretch>
            <a:fillRect/>
          </a:stretch>
        </p:blipFill>
        <p:spPr bwMode="auto">
          <a:xfrm>
            <a:off x="1981200" y="1752600"/>
            <a:ext cx="4114800" cy="3341270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2308860" y="3939540"/>
            <a:ext cx="16702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 smtClean="0">
                <a:solidFill>
                  <a:schemeClr val="bg1"/>
                </a:solidFill>
              </a:rPr>
              <a:t>KO     het    KO    WT    het    </a:t>
            </a:r>
            <a:r>
              <a:rPr lang="en-US" sz="700" b="1" dirty="0" err="1" smtClean="0">
                <a:solidFill>
                  <a:schemeClr val="bg1"/>
                </a:solidFill>
              </a:rPr>
              <a:t>het</a:t>
            </a:r>
            <a:r>
              <a:rPr lang="en-US" sz="700" b="1" dirty="0" smtClean="0">
                <a:solidFill>
                  <a:schemeClr val="bg1"/>
                </a:solidFill>
              </a:rPr>
              <a:t>    WT</a:t>
            </a:r>
            <a:endParaRPr lang="en-US" sz="700" b="1" dirty="0">
              <a:solidFill>
                <a:schemeClr val="bg1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52400" y="6324600"/>
            <a:ext cx="1742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aw data Fig. 1D</a:t>
            </a:r>
            <a:endParaRPr 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0226" y="411480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pic>
        <p:nvPicPr>
          <p:cNvPr id="6" name="Picture 3" descr="Z:\TarbellGroup\GroupMembers\Will\Zbtb32 Projects\Zbtb32 manuscript\Western Fixes\2017-04-21 Zbtb32.tif"/>
          <p:cNvPicPr>
            <a:picLocks noChangeAspect="1" noChangeArrowheads="1"/>
          </p:cNvPicPr>
          <p:nvPr/>
        </p:nvPicPr>
        <p:blipFill>
          <a:blip r:embed="rId2" cstate="print"/>
          <a:stretch>
            <a:fillRect/>
          </a:stretch>
        </p:blipFill>
        <p:spPr bwMode="auto">
          <a:xfrm>
            <a:off x="1749829" y="3352800"/>
            <a:ext cx="3279371" cy="685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4" descr="Z:\TarbellGroup\GroupMembers\Will\Zbtb32 Projects\Zbtb32 manuscript\Western Fixes\2017-04-25 LaminB.tif"/>
          <p:cNvPicPr>
            <a:picLocks noChangeAspect="1" noChangeArrowheads="1"/>
          </p:cNvPicPr>
          <p:nvPr/>
        </p:nvPicPr>
        <p:blipFill>
          <a:blip r:embed="rId3" cstate="print"/>
          <a:stretch>
            <a:fillRect/>
          </a:stretch>
        </p:blipFill>
        <p:spPr bwMode="auto">
          <a:xfrm>
            <a:off x="1219200" y="1066800"/>
            <a:ext cx="4098175" cy="1774767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914389431"/>
              </p:ext>
            </p:extLst>
          </p:nvPr>
        </p:nvGraphicFramePr>
        <p:xfrm>
          <a:off x="2080550" y="4143056"/>
          <a:ext cx="3048000" cy="73374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08000"/>
                <a:gridCol w="508000"/>
                <a:gridCol w="508000"/>
                <a:gridCol w="508000"/>
                <a:gridCol w="508000"/>
                <a:gridCol w="508000"/>
              </a:tblGrid>
              <a:tr h="236984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WT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WT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WT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KO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KO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KO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36984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0 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4 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24 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0 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14 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>
                          <a:solidFill>
                            <a:schemeClr val="tx1"/>
                          </a:solidFill>
                        </a:rPr>
                        <a:t>24 h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59776">
                <a:tc>
                  <a:txBody>
                    <a:bodyPr/>
                    <a:lstStyle/>
                    <a:p>
                      <a:pPr algn="ctr"/>
                      <a:endParaRPr lang="en-US" sz="120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marL="51777" marR="51777" marT="25889" marB="25889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4953000" y="3604550"/>
            <a:ext cx="11429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← Zbtb32, 52 </a:t>
            </a:r>
            <a:r>
              <a:rPr lang="en-US" sz="800" dirty="0" err="1" smtClean="0"/>
              <a:t>kD</a:t>
            </a:r>
            <a:endParaRPr lang="en-US" sz="800" dirty="0"/>
          </a:p>
        </p:txBody>
      </p:sp>
      <p:sp>
        <p:nvSpPr>
          <p:cNvPr id="10" name="TextBox 9"/>
          <p:cNvSpPr txBox="1"/>
          <p:nvPr/>
        </p:nvSpPr>
        <p:spPr>
          <a:xfrm>
            <a:off x="5278892" y="1818806"/>
            <a:ext cx="664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← </a:t>
            </a:r>
            <a:r>
              <a:rPr lang="en-US" sz="800" dirty="0" err="1" smtClean="0"/>
              <a:t>Lamin</a:t>
            </a:r>
            <a:r>
              <a:rPr lang="en-US" sz="800" dirty="0" smtClean="0"/>
              <a:t> B</a:t>
            </a:r>
            <a:endParaRPr lang="en-US" sz="800" dirty="0"/>
          </a:p>
        </p:txBody>
      </p:sp>
      <p:sp>
        <p:nvSpPr>
          <p:cNvPr id="11" name="TextBox 10"/>
          <p:cNvSpPr txBox="1"/>
          <p:nvPr/>
        </p:nvSpPr>
        <p:spPr>
          <a:xfrm>
            <a:off x="5082481" y="4149525"/>
            <a:ext cx="695418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 smtClean="0"/>
              <a:t>genotype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082481" y="4378125"/>
            <a:ext cx="784919" cy="2308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900" dirty="0" smtClean="0"/>
              <a:t>stimulation</a:t>
            </a:r>
            <a:endParaRPr lang="en-US" sz="900" dirty="0"/>
          </a:p>
        </p:txBody>
      </p:sp>
      <p:sp>
        <p:nvSpPr>
          <p:cNvPr id="13" name="TextBox 12"/>
          <p:cNvSpPr txBox="1"/>
          <p:nvPr/>
        </p:nvSpPr>
        <p:spPr>
          <a:xfrm>
            <a:off x="5278892" y="1646900"/>
            <a:ext cx="664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← 76 </a:t>
            </a:r>
            <a:r>
              <a:rPr lang="en-US" sz="800" dirty="0" err="1" smtClean="0"/>
              <a:t>kD</a:t>
            </a:r>
            <a:endParaRPr lang="en-US" sz="800" dirty="0"/>
          </a:p>
        </p:txBody>
      </p:sp>
      <p:sp>
        <p:nvSpPr>
          <p:cNvPr id="14" name="TextBox 13"/>
          <p:cNvSpPr txBox="1"/>
          <p:nvPr/>
        </p:nvSpPr>
        <p:spPr>
          <a:xfrm>
            <a:off x="152400" y="6324600"/>
            <a:ext cx="1742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aw data Fig. 1E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54</Words>
  <Application>Microsoft Office PowerPoint</Application>
  <PresentationFormat>On-screen Show (4:3)</PresentationFormat>
  <Paragraphs>22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illiam Coley</dc:creator>
  <cp:lastModifiedBy>William Coley</cp:lastModifiedBy>
  <cp:revision>1</cp:revision>
  <dcterms:created xsi:type="dcterms:W3CDTF">2018-01-31T20:29:40Z</dcterms:created>
  <dcterms:modified xsi:type="dcterms:W3CDTF">2018-01-31T21:04:54Z</dcterms:modified>
</cp:coreProperties>
</file>